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304"/>
  </p:normalViewPr>
  <p:slideViewPr>
    <p:cSldViewPr snapToGrid="0" snapToObjects="1">
      <p:cViewPr varScale="1">
        <p:scale>
          <a:sx n="99" d="100"/>
          <a:sy n="99" d="100"/>
        </p:scale>
        <p:origin x="5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0B22137-86D3-B149-A0C3-DCA125C884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937C8BC-9AED-7049-B0FA-9C10301E34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903EF50C-229B-2147-89DD-919FE45FA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CF51987-B739-E64D-8CC2-3700027D4A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A53F133C-6BDE-0D44-8BA6-BC8E2BF85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62203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BAC91C7-DA10-EF4C-99BB-D3728F7B4E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E304B271-CBC4-D541-93F4-5396F77BD0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E7BCB392-2956-CF47-9316-E554AEAE7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8018616-175F-7C4D-9650-BAE6EA85C1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F60CA13E-3DA9-F449-8952-B8FEF498E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30827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5FC0BCF-8379-0A4C-960C-77DA3D3AB4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A875CBD4-AFE8-3442-8F4E-58CA6ECAA2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63995C8-659D-2049-94A7-DAC3577AD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A720E38-CE47-894B-8AFD-37BFE7583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3DF9C2D-B132-D145-A140-55A555A80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57186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42F5776-9E2E-1A48-8F82-1A3F8FFD24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F41076EC-70EB-CB49-80D2-71332E6136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2FBCE31-42C2-8344-B3A6-28EDE71B8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77364AEC-9A3A-634A-AA29-760932882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B17B7E6-D726-A747-B532-8599039DF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3694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8409D04-7D99-5443-BA32-F996881830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8A0F6C2-14D9-D64E-B326-F81E725F68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C5D4184-37FF-8E4B-9EAE-1C26F0485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E5DDC53C-7D73-754F-BE8F-E9F868BA1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0C13F186-F339-8F48-9AB3-417D6D6E8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72318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83427ED-0BCB-EE48-8C90-0C89F2DAD1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2AE9CE3C-93D5-8945-AB59-B4E8D36E18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30808C61-FD2C-F74C-8A7B-D190004468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52A6CE41-E980-634D-8BE3-68D9BF488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4704F296-1C6B-4346-8140-2DAA9A3F80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F65FC952-628B-BC46-8634-F10069DC4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56626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6D9DFA4-29C3-C441-AAB7-74E86BBE9C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15313252-DC19-304F-A02C-20340176BC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69F32DDB-59BB-C04E-81E3-390329FDE0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2C37DE9F-B0FA-9643-BA9D-950B6A8E8F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215BD24D-2E7A-F84C-B7B6-8FB01B61DD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B28011B4-EF71-CA4C-BB69-3FD826241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1E46FC2E-016A-B046-B836-7983025356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E967855F-16B4-5C41-A1EB-044279B7A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83692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5EC185B-BF8E-5544-B990-770C73F1F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13FC9179-FF23-CC4D-B6CC-4181BA2A7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87E46AAA-221C-1C43-B86C-7A93E2F55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C40B161E-8367-1C42-8358-B06705230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69385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DD5E8BDE-F78A-2E4E-B80A-AC3D655B9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971B7CDF-F89A-A949-BB9C-EE0D3A56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A0BAD8B5-8ED4-2D4D-B3BF-71C313FC4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38578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4573F20-2896-C94F-87F7-445467643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329C556-EEA1-6E49-9FA8-39249421BD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158C3079-FECA-A843-8D95-9931191BAD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EDC978F9-9A2F-4C4C-94D2-81CB65116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6BCC7138-0651-E248-8EF3-4C1774ED7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D03063A7-0DD2-BA43-BCA5-F666365DA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78095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02F5719-8C7D-D242-9ED7-9A708B7367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763FC00C-C062-CC4A-8729-DD7FE16457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5ED9825D-C2CE-BB49-87A1-B3C5B62CCA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358581F-9EA6-434D-9E8A-55DDF8ED4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33D0C9E2-19CB-CA49-A929-FDE13BBEF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CB73342-1876-D64F-A441-67B59EB63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93016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6756D261-7C20-3146-90B8-DAEF6B5397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62FA8617-4BB1-F947-A3E7-8F8B1CBED1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A5DC658-FF83-904E-B937-C615EA473F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E00841-9288-B840-A709-18CEE8CD4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8EB6A3D-F2E0-3C42-A235-56A8337685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3E92205-D8B6-E64B-8A5A-C8891D344E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0326F4-4BAB-9541-BB36-33C810D3C76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36297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6">
            <a:extLst>
              <a:ext uri="{FF2B5EF4-FFF2-40B4-BE49-F238E27FC236}">
                <a16:creationId xmlns:a16="http://schemas.microsoft.com/office/drawing/2014/main" id="{5DCD41BC-92F5-6F47-9D98-7E558EEB5400}"/>
              </a:ext>
            </a:extLst>
          </p:cNvPr>
          <p:cNvSpPr txBox="1"/>
          <p:nvPr/>
        </p:nvSpPr>
        <p:spPr>
          <a:xfrm>
            <a:off x="930122" y="5076649"/>
            <a:ext cx="9561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Supplement 8: Resistanc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x (RI) – mean difference between all pre-eclampsia and </a:t>
            </a:r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control group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Agrupar 4">
            <a:extLst>
              <a:ext uri="{FF2B5EF4-FFF2-40B4-BE49-F238E27FC236}">
                <a16:creationId xmlns:a16="http://schemas.microsoft.com/office/drawing/2014/main" id="{A24E47BF-DC0A-3444-A7E6-6A9B5C9D3DCE}"/>
              </a:ext>
            </a:extLst>
          </p:cNvPr>
          <p:cNvGrpSpPr/>
          <p:nvPr/>
        </p:nvGrpSpPr>
        <p:grpSpPr>
          <a:xfrm>
            <a:off x="798490" y="1159100"/>
            <a:ext cx="10530625" cy="3408032"/>
            <a:chOff x="0" y="1275388"/>
            <a:chExt cx="12192000" cy="4334933"/>
          </a:xfrm>
        </p:grpSpPr>
        <p:pic>
          <p:nvPicPr>
            <p:cNvPr id="6" name="Picture 2" descr="Chart&#10;&#10;Description automatically generated">
              <a:extLst>
                <a:ext uri="{FF2B5EF4-FFF2-40B4-BE49-F238E27FC236}">
                  <a16:creationId xmlns:a16="http://schemas.microsoft.com/office/drawing/2014/main" id="{02B85319-6531-4346-9E90-AA020FA988A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275388"/>
              <a:ext cx="12192000" cy="4334933"/>
            </a:xfrm>
            <a:prstGeom prst="rect">
              <a:avLst/>
            </a:prstGeom>
          </p:spPr>
        </p:pic>
        <p:sp>
          <p:nvSpPr>
            <p:cNvPr id="7" name="CaixaDeTexto 6">
              <a:extLst>
                <a:ext uri="{FF2B5EF4-FFF2-40B4-BE49-F238E27FC236}">
                  <a16:creationId xmlns:a16="http://schemas.microsoft.com/office/drawing/2014/main" id="{5D0792D1-7827-3D42-8D20-A25FD315FF9A}"/>
                </a:ext>
              </a:extLst>
            </p:cNvPr>
            <p:cNvSpPr txBox="1"/>
            <p:nvPr/>
          </p:nvSpPr>
          <p:spPr>
            <a:xfrm>
              <a:off x="757112" y="4127891"/>
              <a:ext cx="73510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BR" sz="1600" dirty="0">
                  <a:latin typeface="Arial" panose="020B0604020202020204" pitchFamily="34" charset="0"/>
                  <a:cs typeface="Arial" panose="020B0604020202020204" pitchFamily="34" charset="0"/>
                </a:rPr>
                <a:t>202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7918260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9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1</cp:revision>
  <dcterms:created xsi:type="dcterms:W3CDTF">2022-02-06T21:20:03Z</dcterms:created>
  <dcterms:modified xsi:type="dcterms:W3CDTF">2022-02-06T21:21:16Z</dcterms:modified>
</cp:coreProperties>
</file>